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9472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B50067F-A777-0A50-B12A-766B0F8809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85264F2B-07B0-9E43-CF90-CF92234E1A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80C812E0-9B98-F076-204B-5E194583A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2A8266D-98AE-1503-C94A-7C0422462D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6FE5601D-14C8-368E-AC64-C6BBD52CF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6621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F3AC7EF-E1B7-B964-4F60-149130374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75AF7205-52D9-F6E7-7A10-6D7070CC6E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0B797D0F-DFBF-73F9-B338-53799C5F2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4D6F7F2A-2161-8F6E-FC39-1A4CBB598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2DED6FE-1C71-E058-B686-6D2105363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7196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C72181F4-38F9-70E3-417A-D81A8691D9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BBD9D4D1-11CB-173A-ED78-8F63ABFC47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D622B0AC-09DD-6462-AE8E-73527B0DB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6110738-A100-01F2-ED62-0574D3932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DD7A1214-9F0A-4D43-5743-F3E74D8B7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1702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31229C0-D533-3C0D-4A0B-4D542618F1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02A7555D-86B6-F1AA-45AD-8758F87DFA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EB920F3-0CE3-BF11-D8E0-B1FD7F2F5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F02260D9-4067-46A3-2290-0803ED8B5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28E5470B-A44C-063E-17F5-2B5B43AE6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26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88D85F4-EAF7-9722-C1F9-60F87DB731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C55CDD07-3324-DB49-4569-3F2E9ECDD0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644730F5-9D02-29D0-46CD-FE67E6A64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F5ACCA6-5BC8-29C7-174B-EE8B5D200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DA8A061E-C0F3-2F28-169A-CA6FBBA96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8595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0082ED1-ACA4-2058-EE06-97C9BE4EE3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D8CF1D6C-AC27-25CD-F260-5D1E88766E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7C6A3E97-1763-108B-DA1C-7914BC2C64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1389ADBB-553F-1829-D54A-84493049FB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ADB6C00D-1370-0965-8827-6C8E164AC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678C2272-AAB4-90AA-4FC4-11B22934D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2800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202BADE-B0CD-95A4-D4D4-53624D2719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B2E05F44-E430-FB1C-82EA-4592E80C40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AFFF6DAA-56C2-0AD9-B898-B0F5999CF6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78E4BD05-714D-0371-61E2-5E6AD80EC6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B11E195F-7721-2D9A-CFDB-C4E947E528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03828C77-B273-BA8F-2D1C-246744E11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E5A25D56-E41B-A453-E871-2762BF3E0B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1C95EBA5-F378-BD02-2AF8-2D768232C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2910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9964021-250B-35B0-3D96-21EFEF8613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990B67E1-472B-59F6-DF5C-82A7BC8F8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9F8298A4-F5E2-70BE-1342-DF9D77F6D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88196B6C-ECC4-2ECB-3E00-F7E6269DF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6613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DF0D855A-DF9E-1393-B089-4D9D6FE1E0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8FE1B2FB-3FCA-7ADE-2F91-FCC4688AA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FB3A3ED9-B1BD-3C7E-ED13-94F3D122B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8398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0E3EB8D-7956-8C80-8497-018D5E5411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61683A55-A27B-724A-C0C3-1602A38261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923F6906-8B96-F299-A746-F856E99ED9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C8C87300-602F-FCA8-D41F-CB2BE1ABB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792DFE1C-FD33-DFD8-6015-3A3BCE3B4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D81B4A0-848B-52CB-22AF-D7B2C91A9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2264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0B1F469-9F8E-62BC-4786-10102A083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4FF1C821-326D-FB0E-735B-3A0BAD3621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1C83BE02-3498-B0D9-78A7-448763CA81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41865124-1A54-D649-ADE6-D920ECA70A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26CF0D11-687F-F95D-43AF-68B35FD2E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F2E411D3-C417-FB2B-1458-A06A82841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7465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246B6598-BDB8-8E8C-466B-27142355A0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19095A3E-4149-5A42-4792-4318AB3383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1E42A2A2-9E71-E99E-1CEB-7EB1A7A74D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39E4A7-B968-4AED-B83D-C93B4846FF6D}" type="datetimeFigureOut">
              <a:rPr lang="en-GB" smtClean="0"/>
              <a:t>29/10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9E5C07E-C1D6-AA99-5884-6773E1BB09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B45B943-DC6A-A2F9-33D5-AAB04CF9F7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8747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ruta 5">
            <a:extLst>
              <a:ext uri="{FF2B5EF4-FFF2-40B4-BE49-F238E27FC236}">
                <a16:creationId xmlns:a16="http://schemas.microsoft.com/office/drawing/2014/main" id="{8661892D-2D51-3043-2C97-37ED7E543BA3}"/>
              </a:ext>
            </a:extLst>
          </p:cNvPr>
          <p:cNvSpPr txBox="1"/>
          <p:nvPr/>
        </p:nvSpPr>
        <p:spPr>
          <a:xfrm>
            <a:off x="3587262" y="1504472"/>
            <a:ext cx="4302369" cy="8527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Randomized: n=100</a:t>
            </a:r>
          </a:p>
        </p:txBody>
      </p:sp>
      <p:sp>
        <p:nvSpPr>
          <p:cNvPr id="12" name="textruta 11">
            <a:extLst>
              <a:ext uri="{FF2B5EF4-FFF2-40B4-BE49-F238E27FC236}">
                <a16:creationId xmlns:a16="http://schemas.microsoft.com/office/drawing/2014/main" id="{B8A0AF34-33E0-A213-BB5C-1A27662EB37D}"/>
              </a:ext>
            </a:extLst>
          </p:cNvPr>
          <p:cNvSpPr txBox="1"/>
          <p:nvPr/>
        </p:nvSpPr>
        <p:spPr>
          <a:xfrm>
            <a:off x="1792012" y="577543"/>
            <a:ext cx="3581926" cy="5675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Population-based cohort: n=65</a:t>
            </a:r>
          </a:p>
        </p:txBody>
      </p:sp>
      <p:sp>
        <p:nvSpPr>
          <p:cNvPr id="13" name="textruta 12">
            <a:extLst>
              <a:ext uri="{FF2B5EF4-FFF2-40B4-BE49-F238E27FC236}">
                <a16:creationId xmlns:a16="http://schemas.microsoft.com/office/drawing/2014/main" id="{0569257D-4582-3593-0A03-BA1B2A5336B8}"/>
              </a:ext>
            </a:extLst>
          </p:cNvPr>
          <p:cNvSpPr txBox="1"/>
          <p:nvPr/>
        </p:nvSpPr>
        <p:spPr>
          <a:xfrm>
            <a:off x="6095030" y="577542"/>
            <a:ext cx="3581926" cy="5675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New recruits: n=35</a:t>
            </a:r>
          </a:p>
        </p:txBody>
      </p:sp>
      <p:sp>
        <p:nvSpPr>
          <p:cNvPr id="14" name="textruta 13">
            <a:extLst>
              <a:ext uri="{FF2B5EF4-FFF2-40B4-BE49-F238E27FC236}">
                <a16:creationId xmlns:a16="http://schemas.microsoft.com/office/drawing/2014/main" id="{AE0F7232-0574-82B1-2E25-FD9B4137CDAC}"/>
              </a:ext>
            </a:extLst>
          </p:cNvPr>
          <p:cNvSpPr txBox="1"/>
          <p:nvPr/>
        </p:nvSpPr>
        <p:spPr>
          <a:xfrm>
            <a:off x="1792012" y="2705073"/>
            <a:ext cx="3581926" cy="103959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Allocated to intervention: n=50</a:t>
            </a:r>
            <a:endParaRPr lang="en-GB" sz="1600" dirty="0"/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sz="1600" dirty="0"/>
              <a:t>Population based: n=34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sz="1600" dirty="0"/>
              <a:t>New recruits: n=16</a:t>
            </a:r>
          </a:p>
        </p:txBody>
      </p:sp>
      <p:sp>
        <p:nvSpPr>
          <p:cNvPr id="15" name="textruta 14">
            <a:extLst>
              <a:ext uri="{FF2B5EF4-FFF2-40B4-BE49-F238E27FC236}">
                <a16:creationId xmlns:a16="http://schemas.microsoft.com/office/drawing/2014/main" id="{CB119CAA-1C46-2579-7A92-88F974BD0DC0}"/>
              </a:ext>
            </a:extLst>
          </p:cNvPr>
          <p:cNvSpPr txBox="1"/>
          <p:nvPr/>
        </p:nvSpPr>
        <p:spPr>
          <a:xfrm>
            <a:off x="1792012" y="4163672"/>
            <a:ext cx="3581926" cy="103959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endParaRPr lang="en-GB" dirty="0"/>
          </a:p>
          <a:p>
            <a:pPr algn="ctr"/>
            <a:r>
              <a:rPr lang="en-GB" dirty="0"/>
              <a:t>Lost to follow up: n=2</a:t>
            </a:r>
            <a:endParaRPr lang="en-GB" sz="1600" dirty="0"/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Deceased: n=0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Discontinued: n=2</a:t>
            </a:r>
            <a:endParaRPr lang="en-GB" dirty="0"/>
          </a:p>
          <a:p>
            <a:pPr algn="ctr"/>
            <a:endParaRPr lang="en-GB" dirty="0"/>
          </a:p>
        </p:txBody>
      </p:sp>
      <p:sp>
        <p:nvSpPr>
          <p:cNvPr id="16" name="textruta 15">
            <a:extLst>
              <a:ext uri="{FF2B5EF4-FFF2-40B4-BE49-F238E27FC236}">
                <a16:creationId xmlns:a16="http://schemas.microsoft.com/office/drawing/2014/main" id="{16864C88-4626-019C-2A49-37BE830BC539}"/>
              </a:ext>
            </a:extLst>
          </p:cNvPr>
          <p:cNvSpPr txBox="1"/>
          <p:nvPr/>
        </p:nvSpPr>
        <p:spPr>
          <a:xfrm>
            <a:off x="1801732" y="5551074"/>
            <a:ext cx="3581926" cy="11748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Analysed: n=48</a:t>
            </a:r>
            <a:endParaRPr lang="en-GB" sz="1600" dirty="0"/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Knowledge: n=48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Skills: n=12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 err="1"/>
              <a:t>PedsQL</a:t>
            </a:r>
            <a:r>
              <a:rPr lang="en-GB" sz="1600" dirty="0"/>
              <a:t>: n=48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ZCCS: n=48</a:t>
            </a:r>
          </a:p>
        </p:txBody>
      </p:sp>
      <p:sp>
        <p:nvSpPr>
          <p:cNvPr id="17" name="textruta 16">
            <a:extLst>
              <a:ext uri="{FF2B5EF4-FFF2-40B4-BE49-F238E27FC236}">
                <a16:creationId xmlns:a16="http://schemas.microsoft.com/office/drawing/2014/main" id="{CDA694F1-C0FF-7B0F-BAB9-B964CA17F32B}"/>
              </a:ext>
            </a:extLst>
          </p:cNvPr>
          <p:cNvSpPr txBox="1"/>
          <p:nvPr/>
        </p:nvSpPr>
        <p:spPr>
          <a:xfrm>
            <a:off x="6103356" y="2706212"/>
            <a:ext cx="3581926" cy="10384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Allocated to waiting list: n=50</a:t>
            </a:r>
            <a:endParaRPr lang="en-GB" sz="1600" dirty="0"/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sz="1600" dirty="0"/>
              <a:t>Population based: n=31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sz="1600" dirty="0"/>
              <a:t>New recruits: </a:t>
            </a:r>
            <a:r>
              <a:rPr lang="en-GB" sz="1600"/>
              <a:t>n=19</a:t>
            </a:r>
            <a:endParaRPr lang="en-GB" sz="1600" dirty="0"/>
          </a:p>
        </p:txBody>
      </p:sp>
      <p:sp>
        <p:nvSpPr>
          <p:cNvPr id="18" name="textruta 17">
            <a:extLst>
              <a:ext uri="{FF2B5EF4-FFF2-40B4-BE49-F238E27FC236}">
                <a16:creationId xmlns:a16="http://schemas.microsoft.com/office/drawing/2014/main" id="{17052185-DAAF-B03D-7CBF-328B977C41F8}"/>
              </a:ext>
            </a:extLst>
          </p:cNvPr>
          <p:cNvSpPr txBox="1"/>
          <p:nvPr/>
        </p:nvSpPr>
        <p:spPr>
          <a:xfrm>
            <a:off x="6096000" y="4163671"/>
            <a:ext cx="3581926" cy="10384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Lost to follow up: n=4</a:t>
            </a:r>
            <a:endParaRPr lang="en-GB" sz="1600" dirty="0"/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Deceased: n=3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Discontinued: n=1</a:t>
            </a:r>
          </a:p>
        </p:txBody>
      </p:sp>
      <p:sp>
        <p:nvSpPr>
          <p:cNvPr id="19" name="textruta 18">
            <a:extLst>
              <a:ext uri="{FF2B5EF4-FFF2-40B4-BE49-F238E27FC236}">
                <a16:creationId xmlns:a16="http://schemas.microsoft.com/office/drawing/2014/main" id="{9DA4CBED-2705-B889-0E57-5D69B84B1049}"/>
              </a:ext>
            </a:extLst>
          </p:cNvPr>
          <p:cNvSpPr txBox="1"/>
          <p:nvPr/>
        </p:nvSpPr>
        <p:spPr>
          <a:xfrm>
            <a:off x="6095030" y="5522450"/>
            <a:ext cx="3573592" cy="11748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endParaRPr lang="en-GB" dirty="0"/>
          </a:p>
          <a:p>
            <a:pPr algn="ctr"/>
            <a:r>
              <a:rPr lang="en-GB" dirty="0"/>
              <a:t>Analysed n=46</a:t>
            </a:r>
            <a:endParaRPr lang="en-GB" sz="1600" dirty="0"/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Knowledge: n=46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Skills: n=16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 err="1"/>
              <a:t>PedsQL</a:t>
            </a:r>
            <a:r>
              <a:rPr lang="en-GB" sz="1600" dirty="0"/>
              <a:t>: n=46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ZCCS: n=46</a:t>
            </a:r>
          </a:p>
          <a:p>
            <a:pPr lvl="2"/>
            <a:endParaRPr lang="en-GB" sz="1600" dirty="0"/>
          </a:p>
        </p:txBody>
      </p:sp>
      <p:cxnSp>
        <p:nvCxnSpPr>
          <p:cNvPr id="22" name="Koppling: vinklad 21">
            <a:extLst>
              <a:ext uri="{FF2B5EF4-FFF2-40B4-BE49-F238E27FC236}">
                <a16:creationId xmlns:a16="http://schemas.microsoft.com/office/drawing/2014/main" id="{D87D9143-8ADB-C6E4-7842-2EC6F612306E}"/>
              </a:ext>
            </a:extLst>
          </p:cNvPr>
          <p:cNvCxnSpPr>
            <a:cxnSpLocks/>
          </p:cNvCxnSpPr>
          <p:nvPr/>
        </p:nvCxnSpPr>
        <p:spPr>
          <a:xfrm rot="16200000" flipH="1">
            <a:off x="4620930" y="1181335"/>
            <a:ext cx="359370" cy="286901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Koppling: vinklad 24">
            <a:extLst>
              <a:ext uri="{FF2B5EF4-FFF2-40B4-BE49-F238E27FC236}">
                <a16:creationId xmlns:a16="http://schemas.microsoft.com/office/drawing/2014/main" id="{C7AADE83-EEC5-3A75-1139-2CDC1ADAF370}"/>
              </a:ext>
            </a:extLst>
          </p:cNvPr>
          <p:cNvCxnSpPr>
            <a:cxnSpLocks/>
          </p:cNvCxnSpPr>
          <p:nvPr/>
        </p:nvCxnSpPr>
        <p:spPr>
          <a:xfrm rot="5400000">
            <a:off x="6481004" y="1173711"/>
            <a:ext cx="376682" cy="284842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Koppling: vinklad 40">
            <a:extLst>
              <a:ext uri="{FF2B5EF4-FFF2-40B4-BE49-F238E27FC236}">
                <a16:creationId xmlns:a16="http://schemas.microsoft.com/office/drawing/2014/main" id="{1948B07D-63A6-3407-1548-1B0F48AF9211}"/>
              </a:ext>
            </a:extLst>
          </p:cNvPr>
          <p:cNvCxnSpPr>
            <a:cxnSpLocks/>
          </p:cNvCxnSpPr>
          <p:nvPr/>
        </p:nvCxnSpPr>
        <p:spPr>
          <a:xfrm rot="16200000" flipH="1">
            <a:off x="4479803" y="2523064"/>
            <a:ext cx="354726" cy="3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Koppling: vinklad 42">
            <a:extLst>
              <a:ext uri="{FF2B5EF4-FFF2-40B4-BE49-F238E27FC236}">
                <a16:creationId xmlns:a16="http://schemas.microsoft.com/office/drawing/2014/main" id="{90CBFE49-5E34-A657-C53D-B23ACD628646}"/>
              </a:ext>
            </a:extLst>
          </p:cNvPr>
          <p:cNvCxnSpPr>
            <a:cxnSpLocks/>
          </p:cNvCxnSpPr>
          <p:nvPr/>
        </p:nvCxnSpPr>
        <p:spPr>
          <a:xfrm rot="16200000" flipH="1">
            <a:off x="6640708" y="2535734"/>
            <a:ext cx="354726" cy="3"/>
          </a:xfrm>
          <a:prstGeom prst="bentConnector3">
            <a:avLst>
              <a:gd name="adj1" fmla="val 94444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Koppling: vinklad 44">
            <a:extLst>
              <a:ext uri="{FF2B5EF4-FFF2-40B4-BE49-F238E27FC236}">
                <a16:creationId xmlns:a16="http://schemas.microsoft.com/office/drawing/2014/main" id="{67E9FB09-7792-6845-E4F3-3425D86C0C79}"/>
              </a:ext>
            </a:extLst>
          </p:cNvPr>
          <p:cNvCxnSpPr>
            <a:cxnSpLocks/>
          </p:cNvCxnSpPr>
          <p:nvPr/>
        </p:nvCxnSpPr>
        <p:spPr>
          <a:xfrm rot="16200000" flipH="1">
            <a:off x="4444203" y="3950709"/>
            <a:ext cx="425923" cy="3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Koppling: vinklad 46">
            <a:extLst>
              <a:ext uri="{FF2B5EF4-FFF2-40B4-BE49-F238E27FC236}">
                <a16:creationId xmlns:a16="http://schemas.microsoft.com/office/drawing/2014/main" id="{9C2EAC94-1E7E-5AAB-527E-68CF12A52D1E}"/>
              </a:ext>
            </a:extLst>
          </p:cNvPr>
          <p:cNvCxnSpPr>
            <a:cxnSpLocks/>
          </p:cNvCxnSpPr>
          <p:nvPr/>
        </p:nvCxnSpPr>
        <p:spPr>
          <a:xfrm rot="16200000" flipH="1">
            <a:off x="6594088" y="3965164"/>
            <a:ext cx="425923" cy="3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Koppling: vinklad 47">
            <a:extLst>
              <a:ext uri="{FF2B5EF4-FFF2-40B4-BE49-F238E27FC236}">
                <a16:creationId xmlns:a16="http://schemas.microsoft.com/office/drawing/2014/main" id="{942868F5-5B37-AA44-03F0-3572DA7FD98F}"/>
              </a:ext>
            </a:extLst>
          </p:cNvPr>
          <p:cNvCxnSpPr>
            <a:cxnSpLocks/>
          </p:cNvCxnSpPr>
          <p:nvPr/>
        </p:nvCxnSpPr>
        <p:spPr>
          <a:xfrm rot="16200000" flipH="1">
            <a:off x="4477477" y="5382950"/>
            <a:ext cx="359371" cy="1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Koppling: vinklad 49">
            <a:extLst>
              <a:ext uri="{FF2B5EF4-FFF2-40B4-BE49-F238E27FC236}">
                <a16:creationId xmlns:a16="http://schemas.microsoft.com/office/drawing/2014/main" id="{37B8A98C-B064-13B7-409B-B06EA2783CE4}"/>
              </a:ext>
            </a:extLst>
          </p:cNvPr>
          <p:cNvCxnSpPr>
            <a:cxnSpLocks/>
          </p:cNvCxnSpPr>
          <p:nvPr/>
        </p:nvCxnSpPr>
        <p:spPr>
          <a:xfrm rot="16200000" flipH="1">
            <a:off x="6633664" y="5382950"/>
            <a:ext cx="359371" cy="1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98796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1BBC045F673F847A0F0E207AD584339" ma:contentTypeVersion="14" ma:contentTypeDescription="Create a new document." ma:contentTypeScope="" ma:versionID="f4b3f5f1aec76fce41bbb518c96bbd27">
  <xsd:schema xmlns:xsd="http://www.w3.org/2001/XMLSchema" xmlns:xs="http://www.w3.org/2001/XMLSchema" xmlns:p="http://schemas.microsoft.com/office/2006/metadata/properties" xmlns:ns2="f6858cd6-456a-4001-843a-150a322552d6" xmlns:ns3="fcc078ce-31e4-4aca-8629-52703d238027" targetNamespace="http://schemas.microsoft.com/office/2006/metadata/properties" ma:root="true" ma:fieldsID="2b4ceb967bbf49c85e718c57156bae76" ns2:_="" ns3:_="">
    <xsd:import namespace="f6858cd6-456a-4001-843a-150a322552d6"/>
    <xsd:import namespace="fcc078ce-31e4-4aca-8629-52703d23802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DateTaken" minOccurs="0"/>
                <xsd:element ref="ns2:MediaServiceObjectDetectorVersions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Location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6858cd6-456a-4001-843a-150a322552d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1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7" nillable="true" ma:taxonomy="true" ma:internalName="lcf76f155ced4ddcb4097134ff3c332f" ma:taxonomyFieldName="MediaServiceImageTags" ma:displayName="Image Tags" ma:readOnly="false" ma:fieldId="{5cf76f15-5ced-4ddc-b409-7134ff3c332f}" ma:taxonomyMulti="true" ma:sspId="9d595d93-c6d1-4e40-8dc6-545dbb6270d8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BillingMetadata" ma:index="21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cc078ce-31e4-4aca-8629-52703d238027" elementFormDefault="qualified">
    <xsd:import namespace="http://schemas.microsoft.com/office/2006/documentManagement/types"/>
    <xsd:import namespace="http://schemas.microsoft.com/office/infopath/2007/PartnerControls"/>
    <xsd:element name="TaxCatchAll" ma:index="18" nillable="true" ma:displayName="Taxonomy Catch All Column" ma:hidden="true" ma:list="{419b9492-fd1c-40db-9005-4e929a1dd89d}" ma:internalName="TaxCatchAll" ma:showField="CatchAllData" ma:web="fcc078ce-31e4-4aca-8629-52703d23802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f6858cd6-456a-4001-843a-150a322552d6">
      <Terms xmlns="http://schemas.microsoft.com/office/infopath/2007/PartnerControls"/>
    </lcf76f155ced4ddcb4097134ff3c332f>
    <TaxCatchAll xmlns="fcc078ce-31e4-4aca-8629-52703d238027" xsi:nil="true"/>
  </documentManagement>
</p:properties>
</file>

<file path=customXml/itemProps1.xml><?xml version="1.0" encoding="utf-8"?>
<ds:datastoreItem xmlns:ds="http://schemas.openxmlformats.org/officeDocument/2006/customXml" ds:itemID="{7DB31C2F-D8B0-4C5B-BDE8-210CD407D2A0}"/>
</file>

<file path=customXml/itemProps2.xml><?xml version="1.0" encoding="utf-8"?>
<ds:datastoreItem xmlns:ds="http://schemas.openxmlformats.org/officeDocument/2006/customXml" ds:itemID="{01DCF40A-DFAF-48FA-BCCE-324B320CCBC0}"/>
</file>

<file path=customXml/itemProps3.xml><?xml version="1.0" encoding="utf-8"?>
<ds:datastoreItem xmlns:ds="http://schemas.openxmlformats.org/officeDocument/2006/customXml" ds:itemID="{D72B5F44-CE7E-41D8-8A73-DBF2FEAE161B}"/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141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-t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Hans Forssberg</dc:creator>
  <cp:lastModifiedBy>Hans Forssberg</cp:lastModifiedBy>
  <cp:revision>15</cp:revision>
  <cp:lastPrinted>2024-03-06T13:06:42Z</cp:lastPrinted>
  <dcterms:created xsi:type="dcterms:W3CDTF">2024-03-06T12:53:23Z</dcterms:created>
  <dcterms:modified xsi:type="dcterms:W3CDTF">2024-10-29T19:34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1BBC045F673F847A0F0E207AD584339</vt:lpwstr>
  </property>
</Properties>
</file>